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9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FFCCFF"/>
    <a:srgbClr val="A466E8"/>
    <a:srgbClr val="F62402"/>
    <a:srgbClr val="81E1FF"/>
    <a:srgbClr val="64BBFF"/>
    <a:srgbClr val="0066FF"/>
    <a:srgbClr val="FFB1D4"/>
    <a:srgbClr val="B86BE8"/>
    <a:srgbClr val="EA8B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59" autoAdjust="0"/>
    <p:restoredTop sz="94756"/>
  </p:normalViewPr>
  <p:slideViewPr>
    <p:cSldViewPr snapToGrid="0" snapToObjects="1">
      <p:cViewPr varScale="1">
        <p:scale>
          <a:sx n="55" d="100"/>
          <a:sy n="55" d="100"/>
        </p:scale>
        <p:origin x="2196" y="48"/>
      </p:cViewPr>
      <p:guideLst>
        <p:guide orient="horz" pos="2880"/>
        <p:guide pos="2160"/>
      </p:guideLst>
    </p:cSldViewPr>
  </p:slideViewPr>
  <p:notesTextViewPr>
    <p:cViewPr>
      <p:scale>
        <a:sx n="55" d="100"/>
        <a:sy n="55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5255E-8605-3E43-8FE9-7245B3B711D1}" type="datetimeFigureOut">
              <a:rPr lang="en-US" smtClean="0"/>
              <a:t>11/18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2CED0B-E5A3-B546-AA01-0C13C12F229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1986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210D46-8305-4D45-A0F2-06FB4E0B9371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495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C1BB-AA52-B048-B3A3-2E0DCD07DBAA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1250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F8BF6-B504-8544-833C-16673C6A7137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7765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A9E6B-F562-8C4F-BC58-49F5F51DFA96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9231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440D8-65C8-5B40-98CE-EF4E8A9006DF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4540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E7A92-3073-4E4F-BC05-89432EB9E090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7342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EC18D-1ED1-B24D-B21B-EA27D97E7ABC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297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B051-3829-FE4A-A5A4-DF0FEACD6319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250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73BD-3B49-B040-B8A8-695B4B571736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293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5032-A729-7B48-A624-BFE22A8E8458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6928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25F85-7E5D-A14C-9BDE-C26BF4F503C5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1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3E4D-2766-874E-8C73-7B0A6F0AD223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2666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E3C40-833D-5447-901A-C1C9FF365CAB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149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Slide Number Placeholder 4"/>
          <p:cNvSpPr>
            <a:spLocks noGrp="1"/>
          </p:cNvSpPr>
          <p:nvPr>
            <p:ph type="sldNum" sz="quarter" idx="11"/>
          </p:nvPr>
        </p:nvSpPr>
        <p:spPr>
          <a:xfrm>
            <a:off x="2271713" y="11128880"/>
            <a:ext cx="2314575" cy="486833"/>
          </a:xfrm>
        </p:spPr>
        <p:txBody>
          <a:bodyPr/>
          <a:lstStyle/>
          <a:p>
            <a:fld id="{8CE949BB-2176-4E92-BE98-E9A94ED02035}" type="slidenum">
              <a:rPr lang="en-US" sz="800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</a:t>
            </a:fld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Picture 3" descr="Z:\dos\waxman-lab\snp\genotype\script\fig\understanding_intensities_UNC010074671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580" y="475097"/>
            <a:ext cx="1690598" cy="16905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Z:\dos\waxman-lab\snp\genotype\script\munger_et_al\fig\DO_genomes\F02.genotype.probs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0589" y="503439"/>
            <a:ext cx="1581211" cy="15812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" name="Straight Arrow Connector 6"/>
          <p:cNvCxnSpPr/>
          <p:nvPr/>
        </p:nvCxnSpPr>
        <p:spPr>
          <a:xfrm flipV="1">
            <a:off x="1739099" y="1429035"/>
            <a:ext cx="228600" cy="317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itle 1"/>
          <p:cNvSpPr txBox="1">
            <a:spLocks/>
          </p:cNvSpPr>
          <p:nvPr/>
        </p:nvSpPr>
        <p:spPr>
          <a:xfrm>
            <a:off x="1910868" y="1163953"/>
            <a:ext cx="1029182" cy="533338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u="sng" dirty="0">
                <a:latin typeface="Arial" panose="020B0604020202020204" pitchFamily="34" charset="0"/>
                <a:cs typeface="Arial" panose="020B0604020202020204" pitchFamily="34" charset="0"/>
              </a:rPr>
              <a:t>QC: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move samples with low call rates (&lt;90%)</a:t>
            </a:r>
          </a:p>
        </p:txBody>
      </p:sp>
      <p:sp>
        <p:nvSpPr>
          <p:cNvPr id="9" name="Title 1"/>
          <p:cNvSpPr txBox="1">
            <a:spLocks/>
          </p:cNvSpPr>
          <p:nvPr/>
        </p:nvSpPr>
        <p:spPr>
          <a:xfrm>
            <a:off x="241300" y="2067581"/>
            <a:ext cx="1586699" cy="254000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NP array intensities</a:t>
            </a:r>
          </a:p>
        </p:txBody>
      </p:sp>
      <p:sp>
        <p:nvSpPr>
          <p:cNvPr id="13" name="Title 1"/>
          <p:cNvSpPr txBox="1">
            <a:spLocks/>
          </p:cNvSpPr>
          <p:nvPr/>
        </p:nvSpPr>
        <p:spPr>
          <a:xfrm>
            <a:off x="3030533" y="1163953"/>
            <a:ext cx="1143000" cy="533339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etween-batch (quantile) normalization (DOQTL)</a:t>
            </a: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4095750" y="1157572"/>
            <a:ext cx="1167926" cy="711200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under haplotype reconstruction for each DO mouse (DOQTL)</a:t>
            </a:r>
          </a:p>
        </p:txBody>
      </p:sp>
      <p:sp>
        <p:nvSpPr>
          <p:cNvPr id="32" name="Title 1"/>
          <p:cNvSpPr txBox="1">
            <a:spLocks/>
          </p:cNvSpPr>
          <p:nvPr/>
        </p:nvSpPr>
        <p:spPr>
          <a:xfrm>
            <a:off x="1409700" y="2501410"/>
            <a:ext cx="1235701" cy="593522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uantifying gene expression level</a:t>
            </a:r>
          </a:p>
        </p:txBody>
      </p:sp>
      <p:sp>
        <p:nvSpPr>
          <p:cNvPr id="36" name="Title 1"/>
          <p:cNvSpPr txBox="1">
            <a:spLocks/>
          </p:cNvSpPr>
          <p:nvPr/>
        </p:nvSpPr>
        <p:spPr>
          <a:xfrm>
            <a:off x="2655661" y="2419130"/>
            <a:ext cx="979715" cy="745383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Mapping (Tophat2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itle 1"/>
          <p:cNvSpPr txBox="1">
            <a:spLocks/>
          </p:cNvSpPr>
          <p:nvPr/>
        </p:nvSpPr>
        <p:spPr>
          <a:xfrm>
            <a:off x="1314451" y="3359150"/>
            <a:ext cx="1435100" cy="830211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nd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eQTL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r>
              <a:rPr lang="en-US" sz="11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l livers</a:t>
            </a:r>
          </a:p>
          <a:p>
            <a:r>
              <a:rPr lang="en-US" sz="1100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le-only livers</a:t>
            </a:r>
          </a:p>
          <a:p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male-only liver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itle 1"/>
          <p:cNvSpPr txBox="1">
            <a:spLocks/>
          </p:cNvSpPr>
          <p:nvPr/>
        </p:nvSpPr>
        <p:spPr>
          <a:xfrm>
            <a:off x="174317" y="2419130"/>
            <a:ext cx="1194372" cy="745383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wnstream analysis</a:t>
            </a:r>
          </a:p>
        </p:txBody>
      </p:sp>
      <p:cxnSp>
        <p:nvCxnSpPr>
          <p:cNvPr id="59" name="Straight Arrow Connector 58"/>
          <p:cNvCxnSpPr/>
          <p:nvPr/>
        </p:nvCxnSpPr>
        <p:spPr>
          <a:xfrm flipV="1">
            <a:off x="2852917" y="1429035"/>
            <a:ext cx="228600" cy="317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 flipV="1">
            <a:off x="4010646" y="1429035"/>
            <a:ext cx="228600" cy="317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itle 1"/>
          <p:cNvSpPr txBox="1">
            <a:spLocks/>
          </p:cNvSpPr>
          <p:nvPr/>
        </p:nvSpPr>
        <p:spPr>
          <a:xfrm>
            <a:off x="3848100" y="2154129"/>
            <a:ext cx="1536700" cy="711200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struct individual diploid DO genomes for mapping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eqnatur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3" name="Title 1"/>
          <p:cNvSpPr txBox="1">
            <a:spLocks/>
          </p:cNvSpPr>
          <p:nvPr/>
        </p:nvSpPr>
        <p:spPr>
          <a:xfrm>
            <a:off x="161040" y="3427828"/>
            <a:ext cx="1194372" cy="745383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wnstream analysis</a:t>
            </a:r>
          </a:p>
        </p:txBody>
      </p:sp>
      <p:cxnSp>
        <p:nvCxnSpPr>
          <p:cNvPr id="64" name="Straight Arrow Connector 63"/>
          <p:cNvCxnSpPr>
            <a:cxnSpLocks/>
          </p:cNvCxnSpPr>
          <p:nvPr/>
        </p:nvCxnSpPr>
        <p:spPr>
          <a:xfrm flipH="1">
            <a:off x="5340350" y="2222248"/>
            <a:ext cx="568300" cy="266952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cxnSpLocks/>
          </p:cNvCxnSpPr>
          <p:nvPr/>
        </p:nvCxnSpPr>
        <p:spPr>
          <a:xfrm flipH="1">
            <a:off x="2010182" y="3025082"/>
            <a:ext cx="0" cy="25786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>
            <a:cxnSpLocks/>
          </p:cNvCxnSpPr>
          <p:nvPr/>
        </p:nvCxnSpPr>
        <p:spPr>
          <a:xfrm flipH="1">
            <a:off x="3482390" y="2476500"/>
            <a:ext cx="403810" cy="292903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>
            <a:cxnSpLocks/>
          </p:cNvCxnSpPr>
          <p:nvPr/>
        </p:nvCxnSpPr>
        <p:spPr>
          <a:xfrm flipH="1">
            <a:off x="1138734" y="3851319"/>
            <a:ext cx="232866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 flipH="1">
            <a:off x="2580892" y="2795832"/>
            <a:ext cx="24968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/>
          <p:nvPr/>
        </p:nvCxnSpPr>
        <p:spPr>
          <a:xfrm flipH="1">
            <a:off x="1233661" y="2795832"/>
            <a:ext cx="24968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82550" y="440181"/>
            <a:ext cx="6718300" cy="3928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895368" y="15450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  <p:sp>
        <p:nvSpPr>
          <p:cNvPr id="106" name="Title 1"/>
          <p:cNvSpPr txBox="1">
            <a:spLocks/>
          </p:cNvSpPr>
          <p:nvPr/>
        </p:nvSpPr>
        <p:spPr>
          <a:xfrm>
            <a:off x="4010808" y="3047083"/>
            <a:ext cx="979715" cy="397801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NA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ads</a:t>
            </a:r>
          </a:p>
        </p:txBody>
      </p:sp>
      <p:cxnSp>
        <p:nvCxnSpPr>
          <p:cNvPr id="107" name="Straight Arrow Connector 106"/>
          <p:cNvCxnSpPr/>
          <p:nvPr/>
        </p:nvCxnSpPr>
        <p:spPr>
          <a:xfrm flipH="1" flipV="1">
            <a:off x="3482390" y="2820610"/>
            <a:ext cx="611799" cy="337249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>
            <a:cxnSpLocks/>
          </p:cNvCxnSpPr>
          <p:nvPr/>
        </p:nvCxnSpPr>
        <p:spPr>
          <a:xfrm rot="10800000" flipV="1">
            <a:off x="2781728" y="2277260"/>
            <a:ext cx="3329540" cy="1554480"/>
          </a:xfrm>
          <a:prstGeom prst="bentConnector3">
            <a:avLst>
              <a:gd name="adj1" fmla="val 496"/>
            </a:avLst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4B62ED55-9296-8A4B-ADF2-5D527AE83BBF}"/>
              </a:ext>
            </a:extLst>
          </p:cNvPr>
          <p:cNvSpPr txBox="1"/>
          <p:nvPr/>
        </p:nvSpPr>
        <p:spPr>
          <a:xfrm>
            <a:off x="114300" y="889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50E9CBD-09EF-DF49-BB3B-935B8411ECF2}"/>
              </a:ext>
            </a:extLst>
          </p:cNvPr>
          <p:cNvSpPr txBox="1"/>
          <p:nvPr/>
        </p:nvSpPr>
        <p:spPr>
          <a:xfrm>
            <a:off x="939800" y="468630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43A213A-B882-024B-A6DD-2B2435136131}"/>
              </a:ext>
            </a:extLst>
          </p:cNvPr>
          <p:cNvSpPr/>
          <p:nvPr/>
        </p:nvSpPr>
        <p:spPr>
          <a:xfrm>
            <a:off x="1425574" y="3397250"/>
            <a:ext cx="1219200" cy="7683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1FF6D274-EDAA-7344-B9F4-E75E92EEAF8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3675" y="4552316"/>
            <a:ext cx="4336540" cy="3613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8343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90</TotalTime>
  <Words>71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a, Tisha</dc:creator>
  <cp:lastModifiedBy>sathiya vikram</cp:lastModifiedBy>
  <cp:revision>360</cp:revision>
  <cp:lastPrinted>2017-11-21T17:42:59Z</cp:lastPrinted>
  <dcterms:created xsi:type="dcterms:W3CDTF">2017-09-02T16:40:31Z</dcterms:created>
  <dcterms:modified xsi:type="dcterms:W3CDTF">2020-11-18T08:05:57Z</dcterms:modified>
</cp:coreProperties>
</file>